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5929" r:id="rId2"/>
    <p:sldId id="5930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9"/>
    <p:restoredTop sz="94692"/>
  </p:normalViewPr>
  <p:slideViewPr>
    <p:cSldViewPr snapToGrid="0">
      <p:cViewPr varScale="1">
        <p:scale>
          <a:sx n="79" d="100"/>
          <a:sy n="79" d="100"/>
        </p:scale>
        <p:origin x="284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0D8923-5C29-A040-BCF4-136B17F3305A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1563E1-3F1D-E64E-9CAD-2CF8F37E3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569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14CA91-3E16-404D-B73B-C44D15C1A8C0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8817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293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150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41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016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342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141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183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057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095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703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940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939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26" Type="http://schemas.openxmlformats.org/officeDocument/2006/relationships/image" Target="../media/image24.emf"/><Relationship Id="rId39" Type="http://schemas.openxmlformats.org/officeDocument/2006/relationships/image" Target="../media/image37.emf"/><Relationship Id="rId21" Type="http://schemas.openxmlformats.org/officeDocument/2006/relationships/image" Target="../media/image19.emf"/><Relationship Id="rId34" Type="http://schemas.openxmlformats.org/officeDocument/2006/relationships/image" Target="../media/image32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5" Type="http://schemas.openxmlformats.org/officeDocument/2006/relationships/image" Target="../media/image23.emf"/><Relationship Id="rId33" Type="http://schemas.openxmlformats.org/officeDocument/2006/relationships/image" Target="../media/image31.emf"/><Relationship Id="rId38" Type="http://schemas.openxmlformats.org/officeDocument/2006/relationships/image" Target="../media/image36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29" Type="http://schemas.openxmlformats.org/officeDocument/2006/relationships/image" Target="../media/image2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2.emf"/><Relationship Id="rId32" Type="http://schemas.openxmlformats.org/officeDocument/2006/relationships/image" Target="../media/image30.emf"/><Relationship Id="rId37" Type="http://schemas.openxmlformats.org/officeDocument/2006/relationships/image" Target="../media/image35.emf"/><Relationship Id="rId40" Type="http://schemas.openxmlformats.org/officeDocument/2006/relationships/image" Target="../media/image38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23" Type="http://schemas.openxmlformats.org/officeDocument/2006/relationships/image" Target="../media/image21.emf"/><Relationship Id="rId28" Type="http://schemas.openxmlformats.org/officeDocument/2006/relationships/image" Target="../media/image26.emf"/><Relationship Id="rId36" Type="http://schemas.openxmlformats.org/officeDocument/2006/relationships/image" Target="../media/image34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31" Type="http://schemas.openxmlformats.org/officeDocument/2006/relationships/image" Target="../media/image29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emf"/><Relationship Id="rId27" Type="http://schemas.openxmlformats.org/officeDocument/2006/relationships/image" Target="../media/image25.emf"/><Relationship Id="rId30" Type="http://schemas.openxmlformats.org/officeDocument/2006/relationships/image" Target="../media/image28.emf"/><Relationship Id="rId35" Type="http://schemas.openxmlformats.org/officeDocument/2006/relationships/image" Target="../media/image33.png"/><Relationship Id="rId8" Type="http://schemas.openxmlformats.org/officeDocument/2006/relationships/image" Target="../media/image6.emf"/><Relationship Id="rId3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F95CC04-F06B-C5EA-3F43-B49D3675F1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606" y="475111"/>
            <a:ext cx="886746" cy="142723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C1ED705-2D07-6E16-DFE1-B191C32F9D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5713" y="475110"/>
            <a:ext cx="886746" cy="143146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66E27CC-36C3-BD9A-EA54-5B6D838C5D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03143" y="475110"/>
            <a:ext cx="886746" cy="143146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885F830-1F89-F335-EB09-2356EF78430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55909" y="475110"/>
            <a:ext cx="886746" cy="143146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3039055-654A-3B72-83D2-73A1446C60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29526" y="475111"/>
            <a:ext cx="886746" cy="143146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0053C36-D17D-9160-5FC7-DE2A9B03EC7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82290" y="475111"/>
            <a:ext cx="886746" cy="143146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DE2FC3F-3A32-3CE4-3578-B978D8C9AA0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65713" y="1902348"/>
            <a:ext cx="886745" cy="143146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0F81CFD-B752-3893-58C9-8E1F86B2ACA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81429" y="1902348"/>
            <a:ext cx="886745" cy="143146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FD368BB-7BEC-707C-483E-2D647E10E4D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906644" y="1902348"/>
            <a:ext cx="886745" cy="143146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DD2E014-C50F-1EF0-8327-4268828F831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831859" y="1902348"/>
            <a:ext cx="886745" cy="143146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5D3E4A9-EFF2-3EDF-6F68-4C2A372F405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757074" y="1902348"/>
            <a:ext cx="886745" cy="143146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264EEEC-E525-E4E3-16BE-7DF3637954C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682290" y="1902348"/>
            <a:ext cx="920526" cy="143146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7F7DE51-2BE5-0D43-B437-FA6A54B34F5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1606" y="3291020"/>
            <a:ext cx="886745" cy="143146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949985C-2EF1-993A-2F49-87610398FD0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65713" y="3291020"/>
            <a:ext cx="886745" cy="143146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00D856A-890D-1E1C-6B33-19062EB81A5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70574" y="3291020"/>
            <a:ext cx="886745" cy="143146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1E1EEF4-256E-38FF-8CD9-9D1A7550F50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890058" y="3291020"/>
            <a:ext cx="886745" cy="143146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8CD4B6F-7EAB-4666-53E9-F2270C6F5F8A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809542" y="3291020"/>
            <a:ext cx="886745" cy="143146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79BA7F6-B939-BD32-9C5B-025B3656C648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729026" y="3291020"/>
            <a:ext cx="920526" cy="1431461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E906091-A614-95F9-1357-75208731396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682290" y="3291020"/>
            <a:ext cx="886745" cy="1431461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32C2D09F-47F8-D52F-3D08-CBA16C5323A5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922917" y="4705329"/>
            <a:ext cx="886745" cy="1431461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82086473-339B-17AF-C419-AA0BF2ECEF01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842708" y="4705329"/>
            <a:ext cx="886745" cy="1431461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D794896-C3DA-58B3-402B-6DEB6E44672C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762500" y="4705329"/>
            <a:ext cx="886745" cy="1431461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0D414933-43AF-237C-D99F-26D731D508C9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682290" y="4705329"/>
            <a:ext cx="886745" cy="1431461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0762F789-8A0A-36A9-A0BF-B67D7BD4EF31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31606" y="6106930"/>
            <a:ext cx="886745" cy="1431461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30DE2CF7-B51C-34DA-5FC9-1F6F1F725230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1065713" y="6106930"/>
            <a:ext cx="886745" cy="1431461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CA0B4792-B97E-DE3B-3B01-DAC4A65058B0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970574" y="6106930"/>
            <a:ext cx="886745" cy="1431461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1FA518F-F6B2-4BE5-8FDF-219440A8D741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2890058" y="6106930"/>
            <a:ext cx="886745" cy="1431461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26004E9D-D653-F828-D884-F197F67415B6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3809542" y="6106930"/>
            <a:ext cx="920526" cy="1431461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0FA057C0-982A-6280-E340-42CAEB1547FA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4762807" y="6106930"/>
            <a:ext cx="886745" cy="1431461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CE8E7E12-1C72-547B-418E-3E9A1DA719B4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30999" y="7606614"/>
            <a:ext cx="886745" cy="1431461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F6DCB9B6-507C-BB2E-4D50-26F54F76E42B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065713" y="7606614"/>
            <a:ext cx="886745" cy="1431461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E877493A-7960-4BB9-86A2-F5F3488AF571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2000428" y="7606614"/>
            <a:ext cx="886745" cy="1431461"/>
          </a:xfrm>
          <a:prstGeom prst="rect">
            <a:avLst/>
          </a:prstGeom>
        </p:spPr>
      </p:pic>
      <p:pic>
        <p:nvPicPr>
          <p:cNvPr id="1026" name="Picture 2" descr="https://attachments.office.net/owa/CSchurman%40buckinstitute.org/service.svc/s/GetAttachmentThumbnail?id=AAMkADQ2NTQ2MzU4LWU4YWItNDYyNi04MjdjLWRkNDY5ZThlMDZiMwBGAAAAAAAP306lWfVXR4tdjT4RncPcBwBnhSJbBYZPRbEaKYf1Wez%2BAAAAAAEMAABAYsSObCqBTb55N0vLZINFAAFUvKaRAAABEgAQAFBIcE4O76pDoK244bAegqc%3D&amp;thumbnailType=2&amp;token=eyJhbGciOiJSUzI1NiIsImtpZCI6IjczRkI5QkJFRjYzNjc4RDRGN0U4NEI0NDBCQUJCMTJBMzM5RDlGOTgiLCJ0eXAiOiJKV1QiLCJ4NXQiOiJjX3VidnZZMmVOVDM2RXRFQzZ1eEtqT2RuNWcifQ.eyJvcmlnaW4iOiJodHRwczovL291dGxvb2sub2ZmaWNlLmNvbSIsInVjIjoiYTJhMDEwZmY2YzZmNDBmZThlMTRmYmE0OTJjNGRlMjkiLCJzaWduaW5fc3RhdGUiOiJbXCJkdmNfbW5nZFwiLFwiZHZjX2NtcFwiLFwiZHZjX2RtamRcIixcImlua25vd25udHdrXCIsXCJrbXNpXCJdIiwidmVyIjoiRXhjaGFuZ2UuQ2FsbGJhY2suVjEiLCJhcHBjdHhzZW5kZXIiOiJPd2FEb3dubG9hZEAzZTllMDNlZS1iMmQyLTQ2NjctYjRmMC1lMjM3ZjNhODU5NjIiLCJpc3NyaW5nIjoiV1ciLCJhcHBjdHgiOiJ7XCJtc2V4Y2hwcm90XCI6XCJvd2FcIixcInB1aWRcIjpcIjExNTM4MDExMjIzOTEzMTk2MjJcIixcInNjb3BlXCI6XCJPd2FEb3dubG9hZFwiLFwib2lkXCI6XCI3M2RkNjU1Ni04NDM3LTQzODMtYjc0OS03NDNlYzI3MTlkMWRcIixcInByaW1hcnlzaWRcIjpcIlMtMS01LTIxLTEyMTUzMTUzODctMTgwODkzNDgwLTcwMDgxNjQzNy0zMTM2NDUxNlwifSIsIm5iZiI6MTcwMzAyNDk0NiwiZXhwIjoxNzAzMDI1NTQ2LCJpc3MiOiIwMDAwMDAwMi0wMDAwLTBmZjEtY2UwMC0wMDAwMDAwMDAwMDBAM2U5ZTAzZWUtYjJkMi00NjY3LWI0ZjAtZTIzN2YzYTg1OTYyIiwiYXVkIjoiMDAwMDAwMDItMDAwMC0wZmYxLWNlMDAtMDAwMDAwMDAwMDAwL2F0dGFjaG1lbnRzLm9mZmljZS5uZXRAM2U5ZTAzZWUtYjJkMi00NjY3LWI0ZjAtZTIzN2YzYTg1OTYyIiwiaGFwcCI6Im93YSJ9.SlWxa6dDMpKRht_Qptv4C4m1IT1ARTSWLx1Ku023nO13rbVnE5Nxyr09lF2vMQGqIwPTV0tWHQMrWhOf19ybmgiZGGy2IOmFedAKVVsujIpSLia6eAOWdv2k4z7ovrpc7zDytlHvoSa7JysOzt-2nwlAQs-EANhbW7_VFi4TnfU7nyKhxLn8_qiu_hSSNqhFdMJIG6Tkuwvc9_MG-jexDjAI2P2QpgHL-uDv2hvKZlkrrzr3o0YOSY94WK5HLq_uLPdeUrpQrAB6cilzSBGKsmDjYBP2cXDdcI4m09jfEv7Qsdc9FSygbXaX_mgbrg6JZs57YkMgax6lf36X37ObHA&amp;X-OWA-CANARY=w0qpVhESFkKDBWRuU7AFfnC9Fy_iANwY2hQbA7i5GhDQ1AOjwnOtO_dkrj9qD2Jyd_PmnLWwRpU.&amp;owa=outlook.office.com&amp;scriptVer=20231208004.04&amp;clientId=598A6DC2AF90435480FEA57304F69528&amp;animation=true">
            <a:extLst>
              <a:ext uri="{FF2B5EF4-FFF2-40B4-BE49-F238E27FC236}">
                <a16:creationId xmlns:a16="http://schemas.microsoft.com/office/drawing/2014/main" id="{4D28D358-D074-4D1C-B697-4B65591A9A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4371" y="475110"/>
            <a:ext cx="879135" cy="1419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9DB0FD1-982A-0E0B-0CB6-4D34CF61688D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131606" y="1902349"/>
            <a:ext cx="886138" cy="143048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0770B32B-4788-D6E7-EB5B-C0E0868E24FB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131606" y="4705329"/>
            <a:ext cx="919896" cy="143048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20D1BC07-AE4D-A3BA-66B8-4A8FEE5C4F4D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1065712" y="4705329"/>
            <a:ext cx="886138" cy="143048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F27E8889-1B45-5EF9-C2E0-7B161CE2C69D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2003732" y="4705329"/>
            <a:ext cx="886138" cy="143048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E1696209-7F8B-3A15-A7C5-45E18A20B86D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5642655" y="6107911"/>
            <a:ext cx="919896" cy="143048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453A4FA-5354-17FE-0129-431862FD0296}"/>
              </a:ext>
            </a:extLst>
          </p:cNvPr>
          <p:cNvSpPr txBox="1"/>
          <p:nvPr/>
        </p:nvSpPr>
        <p:spPr>
          <a:xfrm>
            <a:off x="168812" y="140678"/>
            <a:ext cx="343251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l Figure 8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1669475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71C89-7ACE-9400-7EB3-B9DDF14EC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420" y="486835"/>
            <a:ext cx="5915025" cy="1227665"/>
          </a:xfrm>
        </p:spPr>
        <p:txBody>
          <a:bodyPr>
            <a:noAutofit/>
          </a:bodyPr>
          <a:lstStyle/>
          <a:p>
            <a:pPr marL="0" marR="0" algn="just">
              <a:lnSpc>
                <a:spcPct val="100000"/>
              </a:lnSpc>
            </a:pPr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8: Tissue-matched OA Medial vs Lateral Candidate m/z Comparisons across entire cohort.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tensities for</a:t>
            </a:r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0 of 44 candidates were significantly increased in OA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cross the patient cohort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y paired one-sided t-test (p&lt; 0.05). 8 additional markers trended towards significance (0.1 &lt; p &lt; 0.05).</a:t>
            </a:r>
          </a:p>
        </p:txBody>
      </p:sp>
    </p:spTree>
    <p:extLst>
      <p:ext uri="{BB962C8B-B14F-4D97-AF65-F5344CB8AC3E}">
        <p14:creationId xmlns:p14="http://schemas.microsoft.com/office/powerpoint/2010/main" val="1025638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59</Words>
  <Application>Microsoft Macintosh PowerPoint</Application>
  <PresentationFormat>Letter Paper (8.5x11 in)</PresentationFormat>
  <Paragraphs>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Supplemental Figure 8: Tissue-matched OA Medial vs Lateral Candidate m/z Comparisons across entire cohort. Intensities for 30 of 44 candidates were significantly increased in OA across the patient cohort by paired one-sided t-test (p&lt; 0.05). 8 additional markers trended towards significance (0.1 &lt; p &lt; 0.05)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Birgit Schilling</cp:lastModifiedBy>
  <cp:revision>21</cp:revision>
  <dcterms:created xsi:type="dcterms:W3CDTF">2024-10-28T17:59:57Z</dcterms:created>
  <dcterms:modified xsi:type="dcterms:W3CDTF">2025-01-22T03:36:26Z</dcterms:modified>
</cp:coreProperties>
</file>